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72523"/>
    <a:srgbClr val="A96631"/>
    <a:srgbClr val="211D1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9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4587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2193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601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8513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4688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611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624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2903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1579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7566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02938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F3F63-1333-4D5D-8CC0-3D2CFAC2F263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0CB14-432A-455C-80DE-3C0A4D35EF6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2459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4" name="그룹 133">
            <a:extLst>
              <a:ext uri="{FF2B5EF4-FFF2-40B4-BE49-F238E27FC236}">
                <a16:creationId xmlns:a16="http://schemas.microsoft.com/office/drawing/2014/main" id="{9781AC50-AF85-47AE-A634-1AE8021D4A6F}"/>
              </a:ext>
            </a:extLst>
          </p:cNvPr>
          <p:cNvGrpSpPr/>
          <p:nvPr/>
        </p:nvGrpSpPr>
        <p:grpSpPr>
          <a:xfrm>
            <a:off x="574924" y="3852434"/>
            <a:ext cx="5708152" cy="1641739"/>
            <a:chOff x="423623" y="4412261"/>
            <a:chExt cx="5490633" cy="1501809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5ACBD0B2-401C-4C81-9D1C-CBBA2DDB5D8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76" t="8747" r="41418"/>
            <a:stretch/>
          </p:blipFill>
          <p:spPr>
            <a:xfrm rot="5400000">
              <a:off x="607750" y="4228134"/>
              <a:ext cx="1497873" cy="1866127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C162462B-EFA4-4E7F-8AAA-96857F66BF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74" t="8747" r="38404"/>
            <a:stretch/>
          </p:blipFill>
          <p:spPr>
            <a:xfrm rot="5400000">
              <a:off x="2475434" y="4291778"/>
              <a:ext cx="1501808" cy="1742775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522B6243-AD00-4BAC-8430-84CD3DC38B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00" t="7584" r="37991"/>
            <a:stretch/>
          </p:blipFill>
          <p:spPr>
            <a:xfrm rot="5400000">
              <a:off x="4287687" y="4287500"/>
              <a:ext cx="1501808" cy="1751331"/>
            </a:xfrm>
            <a:prstGeom prst="rect">
              <a:avLst/>
            </a:prstGeom>
          </p:spPr>
        </p:pic>
      </p:grpSp>
      <p:grpSp>
        <p:nvGrpSpPr>
          <p:cNvPr id="133" name="그룹 132">
            <a:extLst>
              <a:ext uri="{FF2B5EF4-FFF2-40B4-BE49-F238E27FC236}">
                <a16:creationId xmlns:a16="http://schemas.microsoft.com/office/drawing/2014/main" id="{3F620C80-99EC-4377-860F-EE8FD770A94B}"/>
              </a:ext>
            </a:extLst>
          </p:cNvPr>
          <p:cNvGrpSpPr/>
          <p:nvPr/>
        </p:nvGrpSpPr>
        <p:grpSpPr>
          <a:xfrm>
            <a:off x="1171389" y="540895"/>
            <a:ext cx="4409862" cy="2943411"/>
            <a:chOff x="11272212" y="2951479"/>
            <a:chExt cx="3830628" cy="2809240"/>
          </a:xfrm>
        </p:grpSpPr>
        <p:pic>
          <p:nvPicPr>
            <p:cNvPr id="102" name="그림 101">
              <a:extLst>
                <a:ext uri="{FF2B5EF4-FFF2-40B4-BE49-F238E27FC236}">
                  <a16:creationId xmlns:a16="http://schemas.microsoft.com/office/drawing/2014/main" id="{D2EFA5D3-9320-4390-87C3-DF8C169EB4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67" t="7053" r="32676" b="5232"/>
            <a:stretch/>
          </p:blipFill>
          <p:spPr>
            <a:xfrm rot="10800000">
              <a:off x="11272212" y="2951479"/>
              <a:ext cx="3830628" cy="2809240"/>
            </a:xfrm>
            <a:prstGeom prst="rect">
              <a:avLst/>
            </a:prstGeom>
          </p:spPr>
        </p:pic>
        <p:grpSp>
          <p:nvGrpSpPr>
            <p:cNvPr id="103" name="그룹 102">
              <a:extLst>
                <a:ext uri="{FF2B5EF4-FFF2-40B4-BE49-F238E27FC236}">
                  <a16:creationId xmlns:a16="http://schemas.microsoft.com/office/drawing/2014/main" id="{204484F7-5092-4B1A-85BF-7BF22049983F}"/>
                </a:ext>
              </a:extLst>
            </p:cNvPr>
            <p:cNvGrpSpPr/>
            <p:nvPr/>
          </p:nvGrpSpPr>
          <p:grpSpPr>
            <a:xfrm flipV="1">
              <a:off x="13156301" y="3843866"/>
              <a:ext cx="953399" cy="306917"/>
              <a:chOff x="5141845" y="901148"/>
              <a:chExt cx="1047361" cy="220869"/>
            </a:xfrm>
          </p:grpSpPr>
          <p:cxnSp>
            <p:nvCxnSpPr>
              <p:cNvPr id="104" name="직선 연결선 103">
                <a:extLst>
                  <a:ext uri="{FF2B5EF4-FFF2-40B4-BE49-F238E27FC236}">
                    <a16:creationId xmlns:a16="http://schemas.microsoft.com/office/drawing/2014/main" id="{D92F15B0-88ED-43E5-A903-CD5ED3B8B04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06278" y="903151"/>
                <a:ext cx="682928" cy="0"/>
              </a:xfrm>
              <a:prstGeom prst="line">
                <a:avLst/>
              </a:prstGeom>
              <a:noFill/>
              <a:ln>
                <a:solidFill>
                  <a:schemeClr val="bg1"/>
                </a:solidFill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  <p:cxnSp>
            <p:nvCxnSpPr>
              <p:cNvPr id="105" name="직선 연결선 104">
                <a:extLst>
                  <a:ext uri="{FF2B5EF4-FFF2-40B4-BE49-F238E27FC236}">
                    <a16:creationId xmlns:a16="http://schemas.microsoft.com/office/drawing/2014/main" id="{86BF0319-0104-4BD7-9205-041D5BAA272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141845" y="901148"/>
                <a:ext cx="371059" cy="220869"/>
              </a:xfrm>
              <a:prstGeom prst="line">
                <a:avLst/>
              </a:prstGeom>
              <a:noFill/>
              <a:ln>
                <a:solidFill>
                  <a:schemeClr val="bg1"/>
                </a:solidFill>
                <a:headEnd type="none" w="med" len="med"/>
                <a:tailEnd type="arrow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7F9AB976-2722-4A91-8052-6587E7D0AC1D}"/>
                </a:ext>
              </a:extLst>
            </p:cNvPr>
            <p:cNvSpPr txBox="1"/>
            <p:nvPr/>
          </p:nvSpPr>
          <p:spPr>
            <a:xfrm>
              <a:off x="13691354" y="4003484"/>
              <a:ext cx="1148522" cy="277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op block</a:t>
              </a:r>
              <a:endParaRPr lang="ko-KR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AE408F86-C290-4A1B-92E2-CD1FBDDE04CD}"/>
                </a:ext>
              </a:extLst>
            </p:cNvPr>
            <p:cNvSpPr txBox="1"/>
            <p:nvPr/>
          </p:nvSpPr>
          <p:spPr>
            <a:xfrm>
              <a:off x="13793936" y="4998699"/>
              <a:ext cx="1058609" cy="277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ottom block</a:t>
              </a:r>
              <a:endParaRPr lang="ko-KR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B629748-EA02-45CE-B5AB-44E1BB4C266E}"/>
                </a:ext>
              </a:extLst>
            </p:cNvPr>
            <p:cNvSpPr txBox="1"/>
            <p:nvPr/>
          </p:nvSpPr>
          <p:spPr>
            <a:xfrm>
              <a:off x="13427094" y="4275722"/>
              <a:ext cx="1446329" cy="277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pper sliding core</a:t>
              </a:r>
              <a:endParaRPr lang="ko-KR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90D90A62-016D-45E2-88BF-8E3E84401B6B}"/>
                </a:ext>
              </a:extLst>
            </p:cNvPr>
            <p:cNvSpPr txBox="1"/>
            <p:nvPr/>
          </p:nvSpPr>
          <p:spPr>
            <a:xfrm>
              <a:off x="13406593" y="4560919"/>
              <a:ext cx="1446329" cy="277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ower sliding core</a:t>
              </a:r>
              <a:endParaRPr lang="ko-KR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4" name="직선 연결선 113">
              <a:extLst>
                <a:ext uri="{FF2B5EF4-FFF2-40B4-BE49-F238E27FC236}">
                  <a16:creationId xmlns:a16="http://schemas.microsoft.com/office/drawing/2014/main" id="{2C82D514-242B-462A-A5F1-124D7DD5B4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3234172" y="5143548"/>
              <a:ext cx="642663" cy="0"/>
            </a:xfrm>
            <a:prstGeom prst="line">
              <a:avLst/>
            </a:prstGeom>
            <a:noFill/>
            <a:ln>
              <a:solidFill>
                <a:schemeClr val="bg1"/>
              </a:solidFill>
              <a:headEnd type="none" w="med" len="med"/>
              <a:tailEnd type="arrow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1DF5B9E0-267E-4B11-B3EA-41FC51D44AB4}"/>
                </a:ext>
              </a:extLst>
            </p:cNvPr>
            <p:cNvSpPr txBox="1"/>
            <p:nvPr/>
          </p:nvSpPr>
          <p:spPr>
            <a:xfrm>
              <a:off x="13326618" y="3562036"/>
              <a:ext cx="1148522" cy="277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CJ implant</a:t>
              </a:r>
              <a:endParaRPr lang="ko-KR" altLang="en-US" sz="12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6" name="직선 연결선 115">
              <a:extLst>
                <a:ext uri="{FF2B5EF4-FFF2-40B4-BE49-F238E27FC236}">
                  <a16:creationId xmlns:a16="http://schemas.microsoft.com/office/drawing/2014/main" id="{CD0FD65A-1F5E-4C82-8FF5-B2772D4DD36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36178" y="4692229"/>
              <a:ext cx="1223189" cy="0"/>
            </a:xfrm>
            <a:prstGeom prst="line">
              <a:avLst/>
            </a:prstGeom>
            <a:noFill/>
            <a:ln>
              <a:solidFill>
                <a:schemeClr val="bg1"/>
              </a:solidFill>
              <a:headEnd type="none" w="med" len="med"/>
              <a:tailEnd type="arrow" w="med" len="me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grpSp>
          <p:nvGrpSpPr>
            <p:cNvPr id="127" name="그룹 126">
              <a:extLst>
                <a:ext uri="{FF2B5EF4-FFF2-40B4-BE49-F238E27FC236}">
                  <a16:creationId xmlns:a16="http://schemas.microsoft.com/office/drawing/2014/main" id="{0C90957A-9437-4B17-A145-DC53AABD1E25}"/>
                </a:ext>
              </a:extLst>
            </p:cNvPr>
            <p:cNvGrpSpPr/>
            <p:nvPr/>
          </p:nvGrpSpPr>
          <p:grpSpPr>
            <a:xfrm flipV="1">
              <a:off x="12926028" y="4260884"/>
              <a:ext cx="633339" cy="173477"/>
              <a:chOff x="5022419" y="901147"/>
              <a:chExt cx="1166787" cy="198887"/>
            </a:xfrm>
          </p:grpSpPr>
          <p:cxnSp>
            <p:nvCxnSpPr>
              <p:cNvPr id="128" name="직선 연결선 127">
                <a:extLst>
                  <a:ext uri="{FF2B5EF4-FFF2-40B4-BE49-F238E27FC236}">
                    <a16:creationId xmlns:a16="http://schemas.microsoft.com/office/drawing/2014/main" id="{9BF52A5C-179C-4725-A664-5E600413FBC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506278" y="903151"/>
                <a:ext cx="682928" cy="0"/>
              </a:xfrm>
              <a:prstGeom prst="line">
                <a:avLst/>
              </a:prstGeom>
              <a:noFill/>
              <a:ln>
                <a:solidFill>
                  <a:schemeClr val="bg1"/>
                </a:solidFill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  <p:cxnSp>
            <p:nvCxnSpPr>
              <p:cNvPr id="129" name="직선 연결선 128">
                <a:extLst>
                  <a:ext uri="{FF2B5EF4-FFF2-40B4-BE49-F238E27FC236}">
                    <a16:creationId xmlns:a16="http://schemas.microsoft.com/office/drawing/2014/main" id="{64969832-6809-453F-930D-98505C28435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022419" y="901147"/>
                <a:ext cx="490486" cy="198887"/>
              </a:xfrm>
              <a:prstGeom prst="line">
                <a:avLst/>
              </a:prstGeom>
              <a:noFill/>
              <a:ln>
                <a:solidFill>
                  <a:schemeClr val="bg1"/>
                </a:solidFill>
                <a:headEnd type="none" w="med" len="med"/>
                <a:tailEnd type="arrow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8633DBCC-3886-DFE0-790C-AB8C20F4BBCC}"/>
              </a:ext>
            </a:extLst>
          </p:cNvPr>
          <p:cNvSpPr txBox="1"/>
          <p:nvPr/>
        </p:nvSpPr>
        <p:spPr>
          <a:xfrm>
            <a:off x="908424" y="779331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18380E-E55B-02D2-87E3-7EA006547761}"/>
              </a:ext>
            </a:extLst>
          </p:cNvPr>
          <p:cNvSpPr txBox="1"/>
          <p:nvPr/>
        </p:nvSpPr>
        <p:spPr>
          <a:xfrm>
            <a:off x="5094967" y="579265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C7E579-DEEF-7FF8-FEAB-20430190BAFF}"/>
              </a:ext>
            </a:extLst>
          </p:cNvPr>
          <p:cNvSpPr txBox="1"/>
          <p:nvPr/>
        </p:nvSpPr>
        <p:spPr>
          <a:xfrm>
            <a:off x="577275" y="3848136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FFCDF2-5C57-BA96-FD33-5870F50599BB}"/>
              </a:ext>
            </a:extLst>
          </p:cNvPr>
          <p:cNvSpPr txBox="1"/>
          <p:nvPr/>
        </p:nvSpPr>
        <p:spPr>
          <a:xfrm>
            <a:off x="522654" y="7848224"/>
            <a:ext cx="602428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1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abricated novel Rolling Contact Joint (RCJ) implant and four components of molding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actual model of RCJ implant made via molding process and its motion during flexion–extension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ctual model of RCJ implant made via 3D printing and its motion during flexion–extension.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그림 29">
            <a:extLst>
              <a:ext uri="{FF2B5EF4-FFF2-40B4-BE49-F238E27FC236}">
                <a16:creationId xmlns:a16="http://schemas.microsoft.com/office/drawing/2014/main" id="{4DD57534-A69B-45B0-A44A-C7E55CE1CC1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05" t="12035" r="41905" b="2090"/>
          <a:stretch/>
        </p:blipFill>
        <p:spPr>
          <a:xfrm rot="5400000">
            <a:off x="724897" y="5764414"/>
            <a:ext cx="1637437" cy="1940056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96DB4372-CFEF-43F4-9ABF-9A176606CB2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06" t="12034" r="40984" b="4729"/>
          <a:stretch/>
        </p:blipFill>
        <p:spPr>
          <a:xfrm rot="5400000">
            <a:off x="2668616" y="5824234"/>
            <a:ext cx="1637437" cy="1811817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A873A2AA-051B-4AD1-8AC7-2260AA807D8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63" t="9715" r="38730" b="1888"/>
          <a:stretch/>
        </p:blipFill>
        <p:spPr>
          <a:xfrm rot="5400000">
            <a:off x="4552664" y="5828386"/>
            <a:ext cx="1637438" cy="182071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1D074FD-3942-420C-AFD3-91FC6DF51AAA}"/>
              </a:ext>
            </a:extLst>
          </p:cNvPr>
          <p:cNvSpPr txBox="1"/>
          <p:nvPr/>
        </p:nvSpPr>
        <p:spPr>
          <a:xfrm>
            <a:off x="605166" y="5937091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28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016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4</TotalTime>
  <Words>77</Words>
  <Application>Microsoft Office PowerPoint</Application>
  <PresentationFormat>A4 용지(210x297mm)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용재</dc:creator>
  <cp:lastModifiedBy>홍석우</cp:lastModifiedBy>
  <cp:revision>13</cp:revision>
  <dcterms:created xsi:type="dcterms:W3CDTF">2023-11-14T04:11:19Z</dcterms:created>
  <dcterms:modified xsi:type="dcterms:W3CDTF">2023-11-25T01:14:35Z</dcterms:modified>
</cp:coreProperties>
</file>